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907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431A86-60B7-4DBE-A5B7-D1DFC61FF99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0760" y="365040"/>
            <a:ext cx="8543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0760" y="1825200"/>
            <a:ext cx="8543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0760" y="4098240"/>
            <a:ext cx="8543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263E7D-1B37-4595-AAB3-47C44857C19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0760" y="365040"/>
            <a:ext cx="8543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0760" y="1825200"/>
            <a:ext cx="41691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058720" y="1825200"/>
            <a:ext cx="41691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0760" y="4098240"/>
            <a:ext cx="41691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058720" y="4098240"/>
            <a:ext cx="41691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C16639-7D4C-432D-990A-3140D2E534B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0760" y="365040"/>
            <a:ext cx="8543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0760" y="1825200"/>
            <a:ext cx="2750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569400" y="1825200"/>
            <a:ext cx="2750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458040" y="1825200"/>
            <a:ext cx="2750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0760" y="4098240"/>
            <a:ext cx="2750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569400" y="4098240"/>
            <a:ext cx="2750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458040" y="4098240"/>
            <a:ext cx="2750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34217F-7054-4DBE-BA98-73A00C3F380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0760" y="365040"/>
            <a:ext cx="8543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0760" y="1825200"/>
            <a:ext cx="854388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67BF8E-0A13-4900-9B69-5CC20A97192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0760" y="365040"/>
            <a:ext cx="8543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0760" y="1825200"/>
            <a:ext cx="8543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24CED4-351C-402B-85DF-5581D98289D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0760" y="365040"/>
            <a:ext cx="8543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0760" y="1825200"/>
            <a:ext cx="41691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058720" y="1825200"/>
            <a:ext cx="41691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C86D9D-D292-4A91-88BA-32E801A7034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0760" y="365040"/>
            <a:ext cx="8543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B591C8-F2EC-43DE-8B37-D555745BA1F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0760" y="365040"/>
            <a:ext cx="854388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5DA9C8-5B3F-49D6-A75E-775CAE44EA0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0760" y="365040"/>
            <a:ext cx="8543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0760" y="1825200"/>
            <a:ext cx="41691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058720" y="1825200"/>
            <a:ext cx="41691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0760" y="4098240"/>
            <a:ext cx="41691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9A93FC-4415-44D4-949C-0796E1D3AC5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0760" y="365040"/>
            <a:ext cx="8543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0760" y="1825200"/>
            <a:ext cx="41691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058720" y="1825200"/>
            <a:ext cx="41691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058720" y="4098240"/>
            <a:ext cx="41691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45D992-EB3A-4891-BF5C-6EDB26CD0B2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0760" y="365040"/>
            <a:ext cx="8543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0760" y="1825200"/>
            <a:ext cx="41691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058720" y="1825200"/>
            <a:ext cx="41691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0760" y="4098240"/>
            <a:ext cx="8543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9471D9-973E-4BDE-9FB2-8704A265151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0760" y="365040"/>
            <a:ext cx="8543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0760" y="1825200"/>
            <a:ext cx="8543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0760" y="6356520"/>
            <a:ext cx="22287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281040" y="6356520"/>
            <a:ext cx="33433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995880" y="6356520"/>
            <a:ext cx="22287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961DC0D-74A6-49C7-BF0E-A610711587BF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図 3" descr=""/>
          <p:cNvPicPr/>
          <p:nvPr/>
        </p:nvPicPr>
        <p:blipFill>
          <a:blip r:embed="rId1"/>
          <a:stretch/>
        </p:blipFill>
        <p:spPr>
          <a:xfrm>
            <a:off x="1011240" y="195120"/>
            <a:ext cx="7883640" cy="5572440"/>
          </a:xfrm>
          <a:prstGeom prst="rect">
            <a:avLst/>
          </a:prstGeom>
          <a:ln w="0">
            <a:noFill/>
          </a:ln>
        </p:spPr>
      </p:pic>
      <p:sp>
        <p:nvSpPr>
          <p:cNvPr id="42" name="TextBox 566"/>
          <p:cNvSpPr/>
          <p:nvPr/>
        </p:nvSpPr>
        <p:spPr>
          <a:xfrm>
            <a:off x="8213760" y="6478560"/>
            <a:ext cx="1447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1 T.Maki et al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正方形/長方形 1"/>
          <p:cNvSpPr/>
          <p:nvPr/>
        </p:nvSpPr>
        <p:spPr>
          <a:xfrm>
            <a:off x="1011240" y="5979960"/>
            <a:ext cx="8056440" cy="284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ts val="15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1. Meteorological images, OMI aerosol index data and aerosol information at 13:30 UTC on March 14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6-25T21:35:48Z</dcterms:created>
  <dc:creator>牧輝弥</dc:creator>
  <dc:description/>
  <dc:language>en-US</dc:language>
  <cp:lastModifiedBy>牧輝弥</cp:lastModifiedBy>
  <dcterms:modified xsi:type="dcterms:W3CDTF">2016-06-27T23:33:30Z</dcterms:modified>
  <cp:revision>3</cp:revision>
  <dc:subject/>
  <dc:title>PowerPoint プレゼンテーション</dc:title>
</cp:coreProperties>
</file>